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907588"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142262DD-9AB0-4F89-8544-1CF06B1C947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95000" y="274320"/>
            <a:ext cx="8915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95000" y="1600200"/>
            <a:ext cx="89154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95000" y="3964320"/>
            <a:ext cx="89154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D960783-6C3D-4ADC-A75D-321B657B96C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95000" y="274320"/>
            <a:ext cx="8915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95000" y="1600200"/>
            <a:ext cx="4350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5063400" y="1600200"/>
            <a:ext cx="4350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95000" y="3964320"/>
            <a:ext cx="4350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5063400" y="3964320"/>
            <a:ext cx="4350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208146D4-21A2-4AC7-A993-32F384B1F228}"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95000" y="274320"/>
            <a:ext cx="8915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95000" y="1600200"/>
            <a:ext cx="28706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509640" y="1600200"/>
            <a:ext cx="28706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524280" y="1600200"/>
            <a:ext cx="28706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95000" y="3964320"/>
            <a:ext cx="28706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509640" y="3964320"/>
            <a:ext cx="28706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524280" y="3964320"/>
            <a:ext cx="28706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7A22638-CFF9-45CC-B1F1-76C11B02830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95000" y="274320"/>
            <a:ext cx="8915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95000" y="1600200"/>
            <a:ext cx="89154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5E3F40D-C042-4083-B72D-D05DE25ABA0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95000" y="274320"/>
            <a:ext cx="8915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95000" y="1600200"/>
            <a:ext cx="89154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B4B1F81-D97F-42A8-9094-D95C5A0C5AB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95000" y="274320"/>
            <a:ext cx="8915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95000" y="1600200"/>
            <a:ext cx="4350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5063400" y="1600200"/>
            <a:ext cx="4350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F799996-1C6B-4326-B52E-D7B025D5D32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95000" y="274320"/>
            <a:ext cx="8915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5765A4B-4B83-43AD-A46A-1A7AFB0DC4D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95000" y="274320"/>
            <a:ext cx="8915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9B8B6F5-0CCC-4408-B8BC-A512F83F096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95000" y="274320"/>
            <a:ext cx="8915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95000" y="1600200"/>
            <a:ext cx="4350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5063400" y="1600200"/>
            <a:ext cx="4350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95000" y="3964320"/>
            <a:ext cx="4350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BF84265-ABB9-468E-B180-8122DA68099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95000" y="274320"/>
            <a:ext cx="8915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95000" y="1600200"/>
            <a:ext cx="4350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5063400" y="1600200"/>
            <a:ext cx="4350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5063400" y="3964320"/>
            <a:ext cx="4350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F166976-5FA1-4BC1-9655-CD6331244B4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95000" y="274320"/>
            <a:ext cx="8915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95000" y="1600200"/>
            <a:ext cx="4350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5063400" y="1600200"/>
            <a:ext cx="4350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95000" y="3964320"/>
            <a:ext cx="89154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5F3CDEE-49CC-4DAA-B3CC-A88065375E7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95000" y="274320"/>
            <a:ext cx="8915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95000" y="1600200"/>
            <a:ext cx="89154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95360" y="6244920"/>
            <a:ext cx="231120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384360" y="6244920"/>
            <a:ext cx="313668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7098840" y="6244920"/>
            <a:ext cx="231156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C37FAB0-DE4E-46F8-B412-D57864135197}"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1" name=""/>
          <p:cNvGrpSpPr/>
          <p:nvPr/>
        </p:nvGrpSpPr>
        <p:grpSpPr>
          <a:xfrm>
            <a:off x="-11880" y="525600"/>
            <a:ext cx="9918000" cy="6100920"/>
            <a:chOff x="-11880" y="525600"/>
            <a:chExt cx="9918000" cy="6100920"/>
          </a:xfrm>
        </p:grpSpPr>
        <p:sp>
          <p:nvSpPr>
            <p:cNvPr id="42" name=""/>
            <p:cNvSpPr/>
            <p:nvPr/>
          </p:nvSpPr>
          <p:spPr>
            <a:xfrm>
              <a:off x="8131320" y="525600"/>
              <a:ext cx="1774800" cy="333720"/>
            </a:xfrm>
            <a:prstGeom prst="rect">
              <a:avLst/>
            </a:prstGeom>
            <a:noFill/>
            <a:ln w="0">
              <a:noFill/>
            </a:ln>
          </p:spPr>
          <p:style>
            <a:lnRef idx="0"/>
            <a:fillRef idx="0"/>
            <a:effectRef idx="0"/>
            <a:fontRef idx="minor"/>
          </p:style>
          <p:txBody>
            <a:bodyPr lIns="90000" rIns="90000" tIns="46800" bIns="46800" anchor="t">
              <a:spAutoFit/>
            </a:bodyPr>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p:txBody>
        </p:sp>
        <p:sp>
          <p:nvSpPr>
            <p:cNvPr id="43" name=""/>
            <p:cNvSpPr/>
            <p:nvPr/>
          </p:nvSpPr>
          <p:spPr>
            <a:xfrm>
              <a:off x="1316160" y="4156200"/>
              <a:ext cx="182520" cy="198360"/>
            </a:xfrm>
            <a:prstGeom prst="rect">
              <a:avLst/>
            </a:prstGeom>
            <a:solidFill>
              <a:srgbClr val="ffff99"/>
            </a:solidFill>
            <a:ln w="9360">
              <a:solidFill>
                <a:srgbClr val="ffff99"/>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4" name=""/>
            <p:cNvSpPr/>
            <p:nvPr/>
          </p:nvSpPr>
          <p:spPr>
            <a:xfrm>
              <a:off x="1531800" y="4156200"/>
              <a:ext cx="142920" cy="215640"/>
            </a:xfrm>
            <a:prstGeom prst="rect">
              <a:avLst/>
            </a:prstGeom>
            <a:solidFill>
              <a:srgbClr val="ffcc99"/>
            </a:solidFill>
            <a:ln w="9360">
              <a:solidFill>
                <a:srgbClr val="ffcc99"/>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5" name=""/>
            <p:cNvSpPr/>
            <p:nvPr/>
          </p:nvSpPr>
          <p:spPr>
            <a:xfrm>
              <a:off x="1747800" y="5380200"/>
              <a:ext cx="287280" cy="215640"/>
            </a:xfrm>
            <a:prstGeom prst="rect">
              <a:avLst/>
            </a:prstGeom>
            <a:solidFill>
              <a:srgbClr val="66ffcc"/>
            </a:solidFill>
            <a:ln w="9360">
              <a:solidFill>
                <a:srgbClr val="66ffcc">
                  <a:alpha val="50000"/>
                </a:srgbClr>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6" name=""/>
            <p:cNvSpPr/>
            <p:nvPr/>
          </p:nvSpPr>
          <p:spPr>
            <a:xfrm>
              <a:off x="7940520" y="2716200"/>
              <a:ext cx="184320" cy="198360"/>
            </a:xfrm>
            <a:prstGeom prst="rect">
              <a:avLst/>
            </a:prstGeom>
            <a:solidFill>
              <a:srgbClr val="ccff99"/>
            </a:solidFill>
            <a:ln w="9360">
              <a:solidFill>
                <a:srgbClr val="ccff99"/>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7" name=""/>
            <p:cNvSpPr/>
            <p:nvPr/>
          </p:nvSpPr>
          <p:spPr>
            <a:xfrm>
              <a:off x="6283440" y="4156200"/>
              <a:ext cx="242640" cy="198360"/>
            </a:xfrm>
            <a:prstGeom prst="rect">
              <a:avLst/>
            </a:prstGeom>
            <a:solidFill>
              <a:srgbClr val="ffcccc"/>
            </a:solidFill>
            <a:ln w="9360">
              <a:solidFill>
                <a:srgbClr val="ffcccc"/>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8" name=""/>
            <p:cNvSpPr/>
            <p:nvPr/>
          </p:nvSpPr>
          <p:spPr>
            <a:xfrm>
              <a:off x="6067440" y="4156200"/>
              <a:ext cx="182520" cy="198360"/>
            </a:xfrm>
            <a:prstGeom prst="rect">
              <a:avLst/>
            </a:prstGeom>
            <a:solidFill>
              <a:srgbClr val="ffcccc"/>
            </a:solidFill>
            <a:ln w="9360">
              <a:solidFill>
                <a:srgbClr val="ffcccc"/>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9" name=""/>
            <p:cNvSpPr/>
            <p:nvPr/>
          </p:nvSpPr>
          <p:spPr>
            <a:xfrm>
              <a:off x="4411800" y="4156200"/>
              <a:ext cx="792000" cy="215640"/>
            </a:xfrm>
            <a:prstGeom prst="rect">
              <a:avLst/>
            </a:prstGeom>
            <a:solidFill>
              <a:srgbClr val="99ccff"/>
            </a:solidFill>
            <a:ln w="9360">
              <a:solidFill>
                <a:srgbClr val="99cc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0" name=""/>
            <p:cNvSpPr/>
            <p:nvPr/>
          </p:nvSpPr>
          <p:spPr>
            <a:xfrm>
              <a:off x="4411800" y="5380200"/>
              <a:ext cx="792000" cy="215640"/>
            </a:xfrm>
            <a:prstGeom prst="rect">
              <a:avLst/>
            </a:prstGeom>
            <a:solidFill>
              <a:srgbClr val="99ccff"/>
            </a:solidFill>
            <a:ln w="9360">
              <a:solidFill>
                <a:srgbClr val="99cc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1" name=""/>
            <p:cNvSpPr/>
            <p:nvPr/>
          </p:nvSpPr>
          <p:spPr>
            <a:xfrm>
              <a:off x="4411800" y="2716200"/>
              <a:ext cx="863640" cy="216000"/>
            </a:xfrm>
            <a:prstGeom prst="rect">
              <a:avLst/>
            </a:prstGeom>
            <a:solidFill>
              <a:srgbClr val="99ccff"/>
            </a:solidFill>
            <a:ln w="9360">
              <a:solidFill>
                <a:srgbClr val="99cc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2" name=""/>
            <p:cNvSpPr/>
            <p:nvPr/>
          </p:nvSpPr>
          <p:spPr>
            <a:xfrm>
              <a:off x="3403440" y="2716200"/>
              <a:ext cx="366840" cy="198360"/>
            </a:xfrm>
            <a:prstGeom prst="rect">
              <a:avLst/>
            </a:prstGeom>
            <a:solidFill>
              <a:srgbClr val="ffccff"/>
            </a:solidFill>
            <a:ln w="9360">
              <a:solidFill>
                <a:srgbClr val="ffcc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pic>
          <p:nvPicPr>
            <p:cNvPr id="53" name="" descr=""/>
            <p:cNvPicPr/>
            <p:nvPr/>
          </p:nvPicPr>
          <p:blipFill>
            <a:blip r:embed="rId1"/>
            <a:stretch/>
          </p:blipFill>
          <p:spPr>
            <a:xfrm>
              <a:off x="235080" y="2921040"/>
              <a:ext cx="7893000" cy="879480"/>
            </a:xfrm>
            <a:prstGeom prst="rect">
              <a:avLst/>
            </a:prstGeom>
            <a:ln w="0">
              <a:noFill/>
            </a:ln>
          </p:spPr>
        </p:pic>
        <p:grpSp>
          <p:nvGrpSpPr>
            <p:cNvPr id="54" name=""/>
            <p:cNvGrpSpPr/>
            <p:nvPr/>
          </p:nvGrpSpPr>
          <p:grpSpPr>
            <a:xfrm>
              <a:off x="42120" y="4011120"/>
              <a:ext cx="8092800" cy="987840"/>
              <a:chOff x="42120" y="4011120"/>
              <a:chExt cx="8092800" cy="987840"/>
            </a:xfrm>
          </p:grpSpPr>
          <p:pic>
            <p:nvPicPr>
              <p:cNvPr id="55" name="" descr=""/>
              <p:cNvPicPr/>
              <p:nvPr/>
            </p:nvPicPr>
            <p:blipFill>
              <a:blip r:embed="rId2"/>
              <a:stretch/>
            </p:blipFill>
            <p:spPr>
              <a:xfrm>
                <a:off x="201240" y="4349520"/>
                <a:ext cx="7920000" cy="649440"/>
              </a:xfrm>
              <a:prstGeom prst="rect">
                <a:avLst/>
              </a:prstGeom>
              <a:ln w="0">
                <a:noFill/>
              </a:ln>
            </p:spPr>
          </p:pic>
          <p:sp>
            <p:nvSpPr>
              <p:cNvPr id="56" name=""/>
              <p:cNvSpPr/>
              <p:nvPr/>
            </p:nvSpPr>
            <p:spPr>
              <a:xfrm rot="16200000">
                <a:off x="3883680" y="169200"/>
                <a:ext cx="409320" cy="8092800"/>
              </a:xfrm>
              <a:prstGeom prst="rect">
                <a:avLst/>
              </a:prstGeom>
              <a:noFill/>
              <a:ln w="0">
                <a:noFill/>
              </a:ln>
            </p:spPr>
            <p:style>
              <a:lnRef idx="0"/>
              <a:fillRef idx="0"/>
              <a:effectRef idx="0"/>
              <a:fontRef idx="minor"/>
            </p:style>
            <p:txBody>
              <a:bodyPr lIns="90000" rIns="90000" tIns="46800" bIns="46800" anchor="ctr">
                <a:spAutoFit/>
              </a:bodyPr>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amn</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aor</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bl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nbm</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b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fco</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hy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plg</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ecc</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ec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fc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fcc</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fhi</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jc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nc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ret</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ey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fat</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h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he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hlv</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j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ol</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duo</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ill</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jej</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lin</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ourier New"/>
                  </a:rPr>
                  <a:t>sin</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ourier New"/>
                  </a:rPr>
                  <a:t>ej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ourier New"/>
                  </a:rPr>
                  <a:t>nco</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ourier New"/>
                  </a:rPr>
                  <a:t>nj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ourier New"/>
                  </a:rPr>
                  <a:t>cki</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ourier New"/>
                  </a:rPr>
                  <a:t>kid</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cli</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liv</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eli</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fli</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clu</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lun</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elu</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nlu</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cly</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lyg</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lnt</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cg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mc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mg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mg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med</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bf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is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ldo</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mas</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m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s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t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tbr</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vin</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es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nms</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gul</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ov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ov</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pro</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rec</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mu</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nmm</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ag</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sk</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ki</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ton</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ee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eru</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ne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c</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ebs</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fbs</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l</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s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st</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to</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ug</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ag</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t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tes</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ty</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thg</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pty</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fty</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tr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ut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ut</a:t>
                </a:r>
                <a:endParaRPr b="0" lang="en-US" sz="800" spc="-1" strike="noStrike">
                  <a:solidFill>
                    <a:srgbClr val="000000"/>
                  </a:solidFill>
                  <a:latin typeface="Arial"/>
                </a:endParaRPr>
              </a:p>
            </p:txBody>
          </p:sp>
        </p:grpSp>
        <p:sp>
          <p:nvSpPr>
            <p:cNvPr id="57" name=""/>
            <p:cNvSpPr/>
            <p:nvPr/>
          </p:nvSpPr>
          <p:spPr>
            <a:xfrm>
              <a:off x="3152880" y="2276640"/>
              <a:ext cx="191448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iological process</a:t>
              </a:r>
              <a:endParaRPr b="0" lang="en-US" sz="1200" spc="-1" strike="noStrike">
                <a:solidFill>
                  <a:srgbClr val="000000"/>
                </a:solidFill>
                <a:latin typeface="Arial"/>
              </a:endParaRPr>
            </a:p>
          </p:txBody>
        </p:sp>
        <p:sp>
          <p:nvSpPr>
            <p:cNvPr id="58" name=""/>
            <p:cNvSpPr/>
            <p:nvPr/>
          </p:nvSpPr>
          <p:spPr>
            <a:xfrm>
              <a:off x="235080" y="2427120"/>
              <a:ext cx="42696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A</a:t>
              </a:r>
              <a:endParaRPr b="0" lang="en-US" sz="1400" spc="-1" strike="noStrike">
                <a:solidFill>
                  <a:srgbClr val="000000"/>
                </a:solidFill>
                <a:latin typeface="Arial"/>
              </a:endParaRPr>
            </a:p>
          </p:txBody>
        </p:sp>
        <p:sp>
          <p:nvSpPr>
            <p:cNvPr id="59" name=""/>
            <p:cNvSpPr/>
            <p:nvPr/>
          </p:nvSpPr>
          <p:spPr>
            <a:xfrm>
              <a:off x="8083440" y="2644920"/>
              <a:ext cx="1590840" cy="3981600"/>
            </a:xfrm>
            <a:prstGeom prst="rect">
              <a:avLst/>
            </a:prstGeom>
            <a:noFill/>
            <a:ln w="0">
              <a:noFill/>
            </a:ln>
          </p:spPr>
          <p:style>
            <a:lnRef idx="0"/>
            <a:fillRef idx="0"/>
            <a:effectRef idx="0"/>
            <a:fontRef idx="minor"/>
          </p:style>
          <p:txBody>
            <a:bodyPr lIns="90000" rIns="90000" tIns="46800" bIns="46800" anchor="t">
              <a:spAutoFit/>
            </a:bodyPr>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behaviour</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biological process unknown</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cellular process</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development</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growth</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physiological process</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regulation of biological process</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reproduction</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viral life cycle</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cell </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cellular component unknown</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extracellular matrix</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extracellular region</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organelle</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protein complex</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virion</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antioxidant activity</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binding</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catalytic activity</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enzyme regulator activity</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molecular function unknown</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motor activity</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signal transducer activity</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structural molecule activity</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transcription regulator activity</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translation regulator activity</a:t>
              </a:r>
              <a:endParaRPr b="0" lang="en-US" sz="800" spc="-1" strike="noStrike">
                <a:solidFill>
                  <a:srgbClr val="000000"/>
                </a:solidFill>
                <a:latin typeface="Arial"/>
              </a:endParaRPr>
            </a:p>
            <a:p>
              <a:pPr>
                <a:lnSpc>
                  <a:spcPct val="7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Arial"/>
                </a:rPr>
                <a:t>transporter activity</a:t>
              </a:r>
              <a:endParaRPr b="0" lang="en-US" sz="800" spc="-1" strike="noStrike">
                <a:solidFill>
                  <a:srgbClr val="000000"/>
                </a:solidFill>
                <a:latin typeface="Arial"/>
              </a:endParaRPr>
            </a:p>
          </p:txBody>
        </p:sp>
        <p:grpSp>
          <p:nvGrpSpPr>
            <p:cNvPr id="60" name=""/>
            <p:cNvGrpSpPr/>
            <p:nvPr/>
          </p:nvGrpSpPr>
          <p:grpSpPr>
            <a:xfrm>
              <a:off x="42120" y="5235480"/>
              <a:ext cx="8092800" cy="1343160"/>
              <a:chOff x="42120" y="5235480"/>
              <a:chExt cx="8092800" cy="1343160"/>
            </a:xfrm>
          </p:grpSpPr>
          <p:pic>
            <p:nvPicPr>
              <p:cNvPr id="61" name="" descr=""/>
              <p:cNvPicPr/>
              <p:nvPr/>
            </p:nvPicPr>
            <p:blipFill>
              <a:blip r:embed="rId3"/>
              <a:stretch/>
            </p:blipFill>
            <p:spPr>
              <a:xfrm>
                <a:off x="194760" y="5595840"/>
                <a:ext cx="7920000" cy="982800"/>
              </a:xfrm>
              <a:prstGeom prst="rect">
                <a:avLst/>
              </a:prstGeom>
              <a:ln w="0">
                <a:noFill/>
              </a:ln>
            </p:spPr>
          </p:pic>
          <p:sp>
            <p:nvSpPr>
              <p:cNvPr id="62" name=""/>
              <p:cNvSpPr/>
              <p:nvPr/>
            </p:nvSpPr>
            <p:spPr>
              <a:xfrm rot="16200000">
                <a:off x="3880440" y="1397160"/>
                <a:ext cx="416160" cy="8092800"/>
              </a:xfrm>
              <a:prstGeom prst="rect">
                <a:avLst/>
              </a:prstGeom>
              <a:noFill/>
              <a:ln w="0">
                <a:noFill/>
              </a:ln>
            </p:spPr>
            <p:style>
              <a:lnRef idx="0"/>
              <a:fillRef idx="0"/>
              <a:effectRef idx="0"/>
              <a:fontRef idx="minor"/>
            </p:style>
            <p:txBody>
              <a:bodyPr lIns="90000" rIns="90000" tIns="46800" bIns="46800" anchor="ctr">
                <a:spAutoFit/>
              </a:bodyPr>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amn</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aor</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bl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nbm</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b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fco</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hy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plg</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ecc</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ec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fc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fcc</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fhi</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jc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nc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ret</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ey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fat</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h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he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hlv</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j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ol</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duo</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ill</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jej</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lin</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ourier New"/>
                  </a:rPr>
                  <a:t>sin</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ourier New"/>
                  </a:rPr>
                  <a:t>ej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ourier New"/>
                  </a:rPr>
                  <a:t>nco</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ourier New"/>
                  </a:rPr>
                  <a:t>nj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ourier New"/>
                  </a:rPr>
                  <a:t>cki</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ourier New"/>
                  </a:rPr>
                  <a:t>kid</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cli</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liv</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eli</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fli</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clu</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lun</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elu</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nlu</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cly</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lyg</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lnt</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cg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mc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mg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mg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med</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bf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is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ldo</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mas</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m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s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t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tbr</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vin</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es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nms</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gul</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ov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ov</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pro</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rec</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mu</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nmm</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ag</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sk</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ki</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ton</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ee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eru</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ne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c</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ebs</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fbs</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l</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s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st</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to</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ug</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ag</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t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tes</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ty</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thg</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pty</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fty</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tr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ut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ut</a:t>
                </a:r>
                <a:endParaRPr b="0" lang="en-US" sz="800" spc="-1" strike="noStrike">
                  <a:solidFill>
                    <a:srgbClr val="000000"/>
                  </a:solidFill>
                  <a:latin typeface="Arial"/>
                </a:endParaRPr>
              </a:p>
            </p:txBody>
          </p:sp>
        </p:grpSp>
        <p:sp>
          <p:nvSpPr>
            <p:cNvPr id="63" name=""/>
            <p:cNvSpPr/>
            <p:nvPr/>
          </p:nvSpPr>
          <p:spPr>
            <a:xfrm>
              <a:off x="3081240" y="5013360"/>
              <a:ext cx="162720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olecular function</a:t>
              </a:r>
              <a:endParaRPr b="0" lang="en-US" sz="1200" spc="-1" strike="noStrike">
                <a:solidFill>
                  <a:srgbClr val="000000"/>
                </a:solidFill>
                <a:latin typeface="Arial"/>
              </a:endParaRPr>
            </a:p>
          </p:txBody>
        </p:sp>
        <p:sp>
          <p:nvSpPr>
            <p:cNvPr id="64" name=""/>
            <p:cNvSpPr/>
            <p:nvPr/>
          </p:nvSpPr>
          <p:spPr>
            <a:xfrm>
              <a:off x="235080" y="5019840"/>
              <a:ext cx="42696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C</a:t>
              </a:r>
              <a:endParaRPr b="0" lang="en-US" sz="1400" spc="-1" strike="noStrike">
                <a:solidFill>
                  <a:srgbClr val="000000"/>
                </a:solidFill>
                <a:latin typeface="Arial"/>
              </a:endParaRPr>
            </a:p>
          </p:txBody>
        </p:sp>
        <p:sp>
          <p:nvSpPr>
            <p:cNvPr id="65" name=""/>
            <p:cNvSpPr/>
            <p:nvPr/>
          </p:nvSpPr>
          <p:spPr>
            <a:xfrm>
              <a:off x="3152880" y="3789360"/>
              <a:ext cx="177156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ellular component</a:t>
              </a:r>
              <a:endParaRPr b="0" lang="en-US" sz="1200" spc="-1" strike="noStrike">
                <a:solidFill>
                  <a:srgbClr val="000000"/>
                </a:solidFill>
                <a:latin typeface="Arial"/>
              </a:endParaRPr>
            </a:p>
          </p:txBody>
        </p:sp>
        <p:sp>
          <p:nvSpPr>
            <p:cNvPr id="66" name=""/>
            <p:cNvSpPr/>
            <p:nvPr/>
          </p:nvSpPr>
          <p:spPr>
            <a:xfrm>
              <a:off x="235080" y="3795840"/>
              <a:ext cx="42516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B</a:t>
              </a:r>
              <a:endParaRPr b="0" lang="en-US" sz="1400" spc="-1" strike="noStrike">
                <a:solidFill>
                  <a:srgbClr val="000000"/>
                </a:solidFill>
                <a:latin typeface="Arial"/>
              </a:endParaRPr>
            </a:p>
          </p:txBody>
        </p:sp>
        <p:sp>
          <p:nvSpPr>
            <p:cNvPr id="67" name=""/>
            <p:cNvSpPr/>
            <p:nvPr/>
          </p:nvSpPr>
          <p:spPr>
            <a:xfrm>
              <a:off x="4411800" y="2932200"/>
              <a:ext cx="857160" cy="396720"/>
            </a:xfrm>
            <a:prstGeom prst="roundRect">
              <a:avLst>
                <a:gd name="adj" fmla="val 16667"/>
              </a:avLst>
            </a:prstGeom>
            <a:noFill/>
            <a:ln w="38160">
              <a:solidFill>
                <a:srgbClr val="6699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8" name=""/>
            <p:cNvSpPr/>
            <p:nvPr/>
          </p:nvSpPr>
          <p:spPr>
            <a:xfrm>
              <a:off x="3403440" y="3652920"/>
              <a:ext cx="360360" cy="142920"/>
            </a:xfrm>
            <a:prstGeom prst="roundRect">
              <a:avLst>
                <a:gd name="adj" fmla="val 16667"/>
              </a:avLst>
            </a:prstGeom>
            <a:noFill/>
            <a:ln w="38160">
              <a:solidFill>
                <a:srgbClr val="ffcc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9" name=""/>
            <p:cNvSpPr/>
            <p:nvPr/>
          </p:nvSpPr>
          <p:spPr>
            <a:xfrm>
              <a:off x="7940520" y="2932200"/>
              <a:ext cx="184320" cy="131760"/>
            </a:xfrm>
            <a:prstGeom prst="roundRect">
              <a:avLst>
                <a:gd name="adj" fmla="val 16667"/>
              </a:avLst>
            </a:prstGeom>
            <a:noFill/>
            <a:ln w="38160">
              <a:solidFill>
                <a:srgbClr val="ccff99"/>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70" name=""/>
            <p:cNvSpPr/>
            <p:nvPr/>
          </p:nvSpPr>
          <p:spPr>
            <a:xfrm>
              <a:off x="1674720" y="6461280"/>
              <a:ext cx="366840" cy="133200"/>
            </a:xfrm>
            <a:prstGeom prst="roundRect">
              <a:avLst>
                <a:gd name="adj" fmla="val 16667"/>
              </a:avLst>
            </a:prstGeom>
            <a:noFill/>
            <a:ln w="38160">
              <a:solidFill>
                <a:srgbClr val="66ffcc"/>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71" name=""/>
            <p:cNvSpPr/>
            <p:nvPr/>
          </p:nvSpPr>
          <p:spPr>
            <a:xfrm>
              <a:off x="4411800" y="4443480"/>
              <a:ext cx="792000" cy="288720"/>
            </a:xfrm>
            <a:prstGeom prst="roundRect">
              <a:avLst>
                <a:gd name="adj" fmla="val 16667"/>
              </a:avLst>
            </a:prstGeom>
            <a:noFill/>
            <a:ln w="38160">
              <a:solidFill>
                <a:srgbClr val="6699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72" name=""/>
            <p:cNvSpPr/>
            <p:nvPr/>
          </p:nvSpPr>
          <p:spPr>
            <a:xfrm>
              <a:off x="4411800" y="5811840"/>
              <a:ext cx="792000" cy="649440"/>
            </a:xfrm>
            <a:prstGeom prst="roundRect">
              <a:avLst>
                <a:gd name="adj" fmla="val 16667"/>
              </a:avLst>
            </a:prstGeom>
            <a:noFill/>
            <a:ln w="38160">
              <a:solidFill>
                <a:srgbClr val="6699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73" name=""/>
            <p:cNvSpPr/>
            <p:nvPr/>
          </p:nvSpPr>
          <p:spPr>
            <a:xfrm>
              <a:off x="1316160" y="4516560"/>
              <a:ext cx="431640" cy="144360"/>
            </a:xfrm>
            <a:prstGeom prst="roundRect">
              <a:avLst>
                <a:gd name="adj" fmla="val 16667"/>
              </a:avLst>
            </a:prstGeom>
            <a:noFill/>
            <a:ln w="38160">
              <a:solidFill>
                <a:srgbClr val="ffff99"/>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74" name=""/>
            <p:cNvSpPr/>
            <p:nvPr/>
          </p:nvSpPr>
          <p:spPr>
            <a:xfrm>
              <a:off x="6067440" y="4516560"/>
              <a:ext cx="576360" cy="144360"/>
            </a:xfrm>
            <a:prstGeom prst="roundRect">
              <a:avLst>
                <a:gd name="adj" fmla="val 16667"/>
              </a:avLst>
            </a:prstGeom>
            <a:noFill/>
            <a:ln w="38160">
              <a:solidFill>
                <a:srgbClr val="ffcccc"/>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75" name=""/>
            <p:cNvSpPr/>
            <p:nvPr/>
          </p:nvSpPr>
          <p:spPr>
            <a:xfrm rot="16200000">
              <a:off x="3881160" y="-1324800"/>
              <a:ext cx="428760" cy="8215200"/>
            </a:xfrm>
            <a:prstGeom prst="rect">
              <a:avLst/>
            </a:prstGeom>
            <a:noFill/>
            <a:ln w="0">
              <a:noFill/>
            </a:ln>
          </p:spPr>
          <p:style>
            <a:lnRef idx="0"/>
            <a:fillRef idx="0"/>
            <a:effectRef idx="0"/>
            <a:fontRef idx="minor"/>
          </p:style>
          <p:txBody>
            <a:bodyPr lIns="90000" rIns="90000" tIns="46800" bIns="46800" anchor="ctr">
              <a:spAutoFit/>
            </a:bodyPr>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amn</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aor</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bl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nbm</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b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fco</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hy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plg</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ecc</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ec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fc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fcc</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fhi</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jc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nc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ret</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ey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fat</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h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he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hlv</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j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ol</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duo</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ill</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jej</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lin</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ourier New"/>
                </a:rPr>
                <a:t>sin</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ourier New"/>
                </a:rPr>
                <a:t>ej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ourier New"/>
                </a:rPr>
                <a:t>nco</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ourier New"/>
                </a:rPr>
                <a:t>nj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ourier New"/>
                </a:rPr>
                <a:t>cki</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ourier New"/>
                </a:rPr>
                <a:t>kid</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cli</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liv</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eli</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fli</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clu</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lun</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elu</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nlu</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cly</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lyg</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lnt</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cg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mc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mg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mg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med</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bf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is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ldo</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sv-SE" sz="800" spc="-1" strike="noStrike">
                  <a:solidFill>
                    <a:srgbClr val="000000"/>
                  </a:solidFill>
                  <a:latin typeface="Courier New"/>
                </a:rPr>
                <a:t>mas</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m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s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t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tbr</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vin</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es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nms</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gul</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ov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ov</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pro</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rec</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mu</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nmm</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ag</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sk</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ki</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ton</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ee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eru</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ne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c</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ebs</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fbs</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l</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sp</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st</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to</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ug</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ag</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t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tes</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ty</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thg</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pty</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fty</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tra</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ute</a:t>
              </a:r>
              <a:endParaRPr b="0" lang="en-US" sz="800" spc="-1" strike="noStrike">
                <a:solidFill>
                  <a:srgbClr val="000000"/>
                </a:solidFill>
                <a:latin typeface="Arial"/>
              </a:endParaRPr>
            </a:p>
            <a:p>
              <a:pPr>
                <a:lnSpc>
                  <a:spcPct val="7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ut</a:t>
              </a:r>
              <a:endParaRPr b="0" lang="en-US" sz="800" spc="-1" strike="noStrike">
                <a:solidFill>
                  <a:srgbClr val="000000"/>
                </a:solidFill>
                <a:latin typeface="Arial"/>
              </a:endParaRPr>
            </a:p>
          </p:txBody>
        </p:sp>
        <p:pic>
          <p:nvPicPr>
            <p:cNvPr id="76" name="" descr=""/>
            <p:cNvPicPr/>
            <p:nvPr/>
          </p:nvPicPr>
          <p:blipFill>
            <a:blip r:embed="rId4"/>
            <a:stretch/>
          </p:blipFill>
          <p:spPr>
            <a:xfrm>
              <a:off x="7329600" y="1773360"/>
              <a:ext cx="863640" cy="663480"/>
            </a:xfrm>
            <a:prstGeom prst="rect">
              <a:avLst/>
            </a:prstGeom>
            <a:ln w="0">
              <a:noFill/>
            </a:ln>
          </p:spPr>
        </p:pic>
        <p:sp>
          <p:nvSpPr>
            <p:cNvPr id="77" name=""/>
            <p:cNvSpPr/>
            <p:nvPr/>
          </p:nvSpPr>
          <p:spPr>
            <a:xfrm>
              <a:off x="3440160" y="2492280"/>
              <a:ext cx="4825800" cy="52020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1                       2                                                               3   </a:t>
              </a:r>
              <a:endParaRPr b="0" lang="en-US" sz="1400" spc="-1" strike="noStrike">
                <a:solidFill>
                  <a:srgbClr val="000000"/>
                </a:solidFill>
                <a:latin typeface="Arial"/>
              </a:endParaRPr>
            </a:p>
          </p:txBody>
        </p:sp>
        <p:sp>
          <p:nvSpPr>
            <p:cNvPr id="78" name=""/>
            <p:cNvSpPr/>
            <p:nvPr/>
          </p:nvSpPr>
          <p:spPr>
            <a:xfrm>
              <a:off x="1208160" y="3933720"/>
              <a:ext cx="698508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4   5                                                              2                            6 </a:t>
              </a:r>
              <a:endParaRPr b="0" lang="en-US" sz="1400" spc="-1" strike="noStrike">
                <a:solidFill>
                  <a:srgbClr val="000000"/>
                </a:solidFill>
                <a:latin typeface="Arial"/>
              </a:endParaRPr>
            </a:p>
          </p:txBody>
        </p:sp>
        <p:sp>
          <p:nvSpPr>
            <p:cNvPr id="79" name=""/>
            <p:cNvSpPr/>
            <p:nvPr/>
          </p:nvSpPr>
          <p:spPr>
            <a:xfrm>
              <a:off x="1568520" y="5157720"/>
              <a:ext cx="482580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   </a:t>
              </a:r>
              <a:r>
                <a:rPr b="0" lang="en-US" sz="1400" spc="-1" strike="noStrike">
                  <a:solidFill>
                    <a:srgbClr val="000000"/>
                  </a:solidFill>
                  <a:latin typeface="Arial"/>
                </a:rPr>
                <a:t>7                                                         2   </a:t>
              </a:r>
              <a:endParaRPr b="0" lang="en-US" sz="1400" spc="-1" strike="noStrike">
                <a:solidFill>
                  <a:srgbClr val="000000"/>
                </a:solidFill>
                <a:latin typeface="Arial"/>
              </a:endParaRPr>
            </a:p>
          </p:txBody>
        </p:sp>
      </p:grpSp>
      <p:sp>
        <p:nvSpPr>
          <p:cNvPr id="80" name=""/>
          <p:cNvSpPr/>
          <p:nvPr/>
        </p:nvSpPr>
        <p:spPr>
          <a:xfrm>
            <a:off x="200160" y="333360"/>
            <a:ext cx="7993080" cy="1440000"/>
          </a:xfrm>
          <a:prstGeom prst="rect">
            <a:avLst/>
          </a:prstGeom>
          <a:noFill/>
          <a:ln w="0">
            <a:noFill/>
          </a:ln>
        </p:spPr>
        <p:style>
          <a:lnRef idx="0"/>
          <a:fillRef idx="0"/>
          <a:effectRef idx="0"/>
          <a:fontRef idx="minor"/>
        </p:style>
        <p:txBody>
          <a:bodyPr lIns="90000" rIns="90000" tIns="46800" bIns="46800" anchor="t">
            <a:no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Additional file – Figure 1</a:t>
            </a:r>
            <a:r>
              <a:rPr b="0" lang="en-GB" sz="1200" spc="-1" strike="noStrike">
                <a:solidFill>
                  <a:srgbClr val="000000"/>
                </a:solidFill>
                <a:latin typeface="Arial"/>
              </a:rPr>
              <a:t>. Heat maps of the log odds values (in bits) are showing Gene Ontology (GO) content of cDNA libraries and tissues in clusters with predicted alternative splicing for each of the three main classes; A) biological process, B) cellular component and C) molecular function. The libraries are grouped by their corresponding tissues, and the colouring indicates expression levels (i.e. red: high expression, green: low expression). Blue open dots indicate libraries from different developmental stages. The tissue groups are following; 1) lung, 2) muscle, 3) uterus, 4) joint capsule, 5) eye, 6) skin and 7) heart. For further information on libraries see table below.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5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1-16T12:10:27Z</dcterms:created>
  <dc:creator>abn</dc:creator>
  <dc:description/>
  <dc:language>en-US</dc:language>
  <cp:lastModifiedBy>Merete Fredholm</cp:lastModifiedBy>
  <dcterms:modified xsi:type="dcterms:W3CDTF">2010-04-13T09:35:41Z</dcterms:modified>
  <cp:revision>9</cp:revision>
  <dc:subject/>
  <dc:title>Dias nummer 1</dc:title>
</cp:coreProperties>
</file>